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1A5C0-BADA-43E4-B50E-2EE42D3280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C90D4-5E43-4F0E-8063-321589ACCF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59BE5-BC8E-425E-964A-5952D0F575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9BA10-4AD3-4DD8-A049-A27D6A6429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3842F-2B1B-408F-94F8-5776E1FB51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003CB-EF6F-49C6-9222-2C2C789EF1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DA59D-53B9-42C2-BD9A-9DC7CDB7DB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D579E-236F-4D5E-AA59-1DDC2AEE9B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8D1B2-590E-451E-83BA-F0F22DCD33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593EF-BC7C-4547-AB1F-24B2136DD8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67F74-8184-44EA-ADA7-A310117EA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51E17-51C3-43D9-9F38-621D300FAB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F2D565-5BB9-44E1-AC38-83595708F27C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272520" y="272880"/>
            <a:ext cx="436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Table S1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utational status of pancreatic cell lines used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04640" y="628560"/>
          <a:ext cx="4773960" cy="5116680"/>
        </p:xfrm>
        <a:graphic>
          <a:graphicData uri="http://schemas.openxmlformats.org/drawingml/2006/table">
            <a:tbl>
              <a:tblPr/>
              <a:tblGrid>
                <a:gridCol w="1044720"/>
                <a:gridCol w="927000"/>
                <a:gridCol w="949320"/>
                <a:gridCol w="890640"/>
                <a:gridCol w="962280"/>
              </a:tblGrid>
              <a:tr h="279360">
                <a:tc>
                  <a:txBody>
                    <a:bodyPr anchor="t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-Ra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N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AD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C-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59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3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7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er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FPAC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24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PA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PAF-I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51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A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(NV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.6p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A 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(NV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A PaC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48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7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 02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A 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(NV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48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0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 03.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V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ronic substitu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 04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A 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(NV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kn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 08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er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 1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255N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W 19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anchor="ctr">
                      <a:noAutofit/>
                    </a:bodyPr>
                    <a:p>
                      <a:pPr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spcAft>
                          <a:spcPts val="4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7T07:31:12Z</dcterms:created>
  <dc:creator>hofmair1</dc:creator>
  <dc:description/>
  <dc:language>en-US</dc:language>
  <cp:lastModifiedBy>hofmair1</cp:lastModifiedBy>
  <dcterms:modified xsi:type="dcterms:W3CDTF">2012-03-18T13:31:05Z</dcterms:modified>
  <cp:revision>25</cp:revision>
  <dc:subject/>
  <dc:title>Slide 1</dc:title>
</cp:coreProperties>
</file>